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xmlns="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00" autoAdjust="0"/>
    <p:restoredTop sz="94660"/>
  </p:normalViewPr>
  <p:slideViewPr>
    <p:cSldViewPr snapToGrid="0">
      <p:cViewPr varScale="1">
        <p:scale>
          <a:sx n="70" d="100"/>
          <a:sy n="70" d="100"/>
        </p:scale>
        <p:origin x="-708" y="-96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9A8652-9D60-4EE1-95C6-C8E6A2AEB8FD}" type="datetimeFigureOut">
              <a:rPr lang="en-US" smtClean="0"/>
              <a:t>10/3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88AC46-E8F8-48B2-B3D9-DE24F1428F0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5879542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9A8652-9D60-4EE1-95C6-C8E6A2AEB8FD}" type="datetimeFigureOut">
              <a:rPr lang="en-US" smtClean="0"/>
              <a:t>10/3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88AC46-E8F8-48B2-B3D9-DE24F1428F0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601510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9A8652-9D60-4EE1-95C6-C8E6A2AEB8FD}" type="datetimeFigureOut">
              <a:rPr lang="en-US" smtClean="0"/>
              <a:t>10/3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88AC46-E8F8-48B2-B3D9-DE24F1428F0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688130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9A8652-9D60-4EE1-95C6-C8E6A2AEB8FD}" type="datetimeFigureOut">
              <a:rPr lang="en-US" smtClean="0"/>
              <a:t>10/3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88AC46-E8F8-48B2-B3D9-DE24F1428F0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9756907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9A8652-9D60-4EE1-95C6-C8E6A2AEB8FD}" type="datetimeFigureOut">
              <a:rPr lang="en-US" smtClean="0"/>
              <a:t>10/3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88AC46-E8F8-48B2-B3D9-DE24F1428F0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8341590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9A8652-9D60-4EE1-95C6-C8E6A2AEB8FD}" type="datetimeFigureOut">
              <a:rPr lang="en-US" smtClean="0"/>
              <a:t>10/3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88AC46-E8F8-48B2-B3D9-DE24F1428F0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1816191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9A8652-9D60-4EE1-95C6-C8E6A2AEB8FD}" type="datetimeFigureOut">
              <a:rPr lang="en-US" smtClean="0"/>
              <a:t>10/3/2021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88AC46-E8F8-48B2-B3D9-DE24F1428F0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2899211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9A8652-9D60-4EE1-95C6-C8E6A2AEB8FD}" type="datetimeFigureOut">
              <a:rPr lang="en-US" smtClean="0"/>
              <a:t>10/3/2021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88AC46-E8F8-48B2-B3D9-DE24F1428F0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0395104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9A8652-9D60-4EE1-95C6-C8E6A2AEB8FD}" type="datetimeFigureOut">
              <a:rPr lang="en-US" smtClean="0"/>
              <a:t>10/3/2021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88AC46-E8F8-48B2-B3D9-DE24F1428F0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5503066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9A8652-9D60-4EE1-95C6-C8E6A2AEB8FD}" type="datetimeFigureOut">
              <a:rPr lang="en-US" smtClean="0"/>
              <a:t>10/3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88AC46-E8F8-48B2-B3D9-DE24F1428F0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2961009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9A8652-9D60-4EE1-95C6-C8E6A2AEB8FD}" type="datetimeFigureOut">
              <a:rPr lang="en-US" smtClean="0"/>
              <a:t>10/3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88AC46-E8F8-48B2-B3D9-DE24F1428F0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76244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D9A8652-9D60-4EE1-95C6-C8E6A2AEB8FD}" type="datetimeFigureOut">
              <a:rPr lang="en-US" smtClean="0"/>
              <a:t>10/3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488AC46-E8F8-48B2-B3D9-DE24F1428F0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0481092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4.jpeg"/><Relationship Id="rId4" Type="http://schemas.openxmlformats.org/officeDocument/2006/relationships/image" Target="../media/image3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9" name="Group 8"/>
          <p:cNvGrpSpPr/>
          <p:nvPr/>
        </p:nvGrpSpPr>
        <p:grpSpPr>
          <a:xfrm>
            <a:off x="388959" y="953037"/>
            <a:ext cx="11124753" cy="3128249"/>
            <a:chOff x="388959" y="953037"/>
            <a:chExt cx="11124753" cy="3128249"/>
          </a:xfrm>
        </p:grpSpPr>
        <p:pic>
          <p:nvPicPr>
            <p:cNvPr id="4" name="Picture 3"/>
            <p:cNvPicPr>
              <a:picLocks noChangeAspect="1"/>
            </p:cNvPicPr>
            <p:nvPr/>
          </p:nvPicPr>
          <p:blipFill rotWithShape="1"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9577" t="7768" r="27887" b="8602"/>
            <a:stretch/>
          </p:blipFill>
          <p:spPr>
            <a:xfrm rot="5400000">
              <a:off x="3107832" y="949015"/>
              <a:ext cx="2678803" cy="2686849"/>
            </a:xfrm>
            <a:prstGeom prst="rect">
              <a:avLst/>
            </a:prstGeom>
          </p:spPr>
        </p:pic>
        <p:pic>
          <p:nvPicPr>
            <p:cNvPr id="5" name="Picture 4"/>
            <p:cNvPicPr>
              <a:picLocks noChangeAspect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9953" t="7517" r="26197" b="6849"/>
            <a:stretch/>
          </p:blipFill>
          <p:spPr>
            <a:xfrm rot="5400000">
              <a:off x="5945041" y="945161"/>
              <a:ext cx="2678804" cy="2694562"/>
            </a:xfrm>
            <a:prstGeom prst="rect">
              <a:avLst/>
            </a:prstGeom>
          </p:spPr>
        </p:pic>
        <p:pic>
          <p:nvPicPr>
            <p:cNvPr id="6" name="Picture 5"/>
            <p:cNvPicPr>
              <a:picLocks noChangeAspect="1"/>
            </p:cNvPicPr>
            <p:nvPr/>
          </p:nvPicPr>
          <p:blipFill rotWithShape="1"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9014" t="5514" r="23380" b="5598"/>
            <a:stretch/>
          </p:blipFill>
          <p:spPr>
            <a:xfrm rot="5400000">
              <a:off x="370356" y="971640"/>
              <a:ext cx="2678803" cy="2641598"/>
            </a:xfrm>
            <a:prstGeom prst="rect">
              <a:avLst/>
            </a:prstGeom>
          </p:spPr>
        </p:pic>
        <p:sp>
          <p:nvSpPr>
            <p:cNvPr id="7" name="TextBox 6"/>
            <p:cNvSpPr txBox="1"/>
            <p:nvPr/>
          </p:nvSpPr>
          <p:spPr>
            <a:xfrm>
              <a:off x="1287887" y="3773509"/>
              <a:ext cx="10225825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ESK1                                                     ESK17                                                   ESM17                                  ESR15 (</a:t>
              </a:r>
              <a:r>
                <a:rPr lang="en-US" sz="1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</a:t>
              </a:r>
              <a:r>
                <a:rPr lang="en-US" sz="14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ositive control)</a:t>
              </a:r>
              <a:endParaRPr lang="en-US" sz="14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pic>
          <p:nvPicPr>
            <p:cNvPr id="8" name="Picture 7"/>
            <p:cNvPicPr>
              <a:picLocks noChangeAspect="1"/>
            </p:cNvPicPr>
            <p:nvPr/>
          </p:nvPicPr>
          <p:blipFill rotWithShape="1"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0328" t="7768" r="22629" b="5847"/>
            <a:stretch/>
          </p:blipFill>
          <p:spPr>
            <a:xfrm rot="5400000">
              <a:off x="8733207" y="998061"/>
              <a:ext cx="2678804" cy="2588762"/>
            </a:xfrm>
            <a:prstGeom prst="rect">
              <a:avLst/>
            </a:prstGeom>
          </p:spPr>
        </p:pic>
      </p:grpSp>
      <p:sp>
        <p:nvSpPr>
          <p:cNvPr id="10" name="TextBox 9"/>
          <p:cNvSpPr txBox="1"/>
          <p:nvPr/>
        </p:nvSpPr>
        <p:spPr>
          <a:xfrm>
            <a:off x="0" y="4494727"/>
            <a:ext cx="1219200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</a:t>
            </a:r>
            <a:r>
              <a:rPr lang="en-US" sz="16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3. </a:t>
            </a:r>
            <a:r>
              <a:rPr lang="en-US" sz="16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HCN production by the isolates of ESK17 and ESM17 along with positive control (</a:t>
            </a:r>
            <a:r>
              <a:rPr lang="en-US" sz="16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seudomonas chlororaphis </a:t>
            </a:r>
            <a:r>
              <a:rPr lang="en-US" sz="16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ESR15)  </a:t>
            </a:r>
            <a:endParaRPr 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8975370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1</TotalTime>
  <Words>30</Words>
  <Application>Microsoft Office PowerPoint</Application>
  <PresentationFormat>Custom</PresentationFormat>
  <Paragraphs>2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anjurul</dc:creator>
  <cp:lastModifiedBy>Dr. Md. Manju</cp:lastModifiedBy>
  <cp:revision>4</cp:revision>
  <dcterms:created xsi:type="dcterms:W3CDTF">2021-03-09T09:12:41Z</dcterms:created>
  <dcterms:modified xsi:type="dcterms:W3CDTF">2021-10-03T08:16:12Z</dcterms:modified>
</cp:coreProperties>
</file>